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4" r:id="rId2"/>
    <p:sldId id="265" r:id="rId3"/>
    <p:sldId id="257" r:id="rId4"/>
    <p:sldId id="256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36" autoAdjust="0"/>
    <p:restoredTop sz="92523" autoAdjust="0"/>
  </p:normalViewPr>
  <p:slideViewPr>
    <p:cSldViewPr snapToGrid="0">
      <p:cViewPr varScale="1">
        <p:scale>
          <a:sx n="105" d="100"/>
          <a:sy n="105" d="100"/>
        </p:scale>
        <p:origin x="144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335D79-E3A3-4EF3-A94E-7893E8669C9B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0D2004-3C79-457B-AC2A-31B665471C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4354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0D2004-3C79-457B-AC2A-31B665471C2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6291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0D2004-3C79-457B-AC2A-31B665471C2E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8940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0D2004-3C79-457B-AC2A-31B665471C2E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6991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0D2004-3C79-457B-AC2A-31B665471C2E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567297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0D2004-3C79-457B-AC2A-31B665471C2E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397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012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8269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59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7558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4983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5085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7934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2245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113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446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7818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8F642-DAFC-407B-95E8-97DA4C2FD4BA}" type="datetimeFigureOut">
              <a:rPr lang="zh-CN" altLang="en-US" smtClean="0"/>
              <a:t>2022/7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5035F-8FD7-4936-A908-F0C1FAE6E5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090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8" t="12393" r="17873" b="2525"/>
          <a:stretch/>
        </p:blipFill>
        <p:spPr>
          <a:xfrm>
            <a:off x="2694596" y="577521"/>
            <a:ext cx="5701263" cy="4901471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694596" y="5602528"/>
            <a:ext cx="8620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Control              10</a:t>
            </a:r>
            <a:r>
              <a:rPr lang="en-US" altLang="zh-CN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                      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US" altLang="zh-CN" baseline="30000" dirty="0">
                <a:latin typeface="Calibri" panose="020F0502020204030204" pitchFamily="34" charset="0"/>
                <a:cs typeface="Calibri" panose="020F0502020204030204" pitchFamily="34" charset="0"/>
              </a:rPr>
              <a:t>7                              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US" altLang="zh-CN" baseline="30000" dirty="0">
                <a:latin typeface="Calibri" panose="020F0502020204030204" pitchFamily="34" charset="0"/>
                <a:cs typeface="Calibri" panose="020F0502020204030204" pitchFamily="34" charset="0"/>
              </a:rPr>
              <a:t>8                             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US" altLang="zh-CN" baseline="30000" dirty="0">
                <a:latin typeface="Calibri" panose="020F0502020204030204" pitchFamily="34" charset="0"/>
                <a:cs typeface="Calibri" panose="020F0502020204030204" pitchFamily="34" charset="0"/>
              </a:rPr>
              <a:t>9        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1585750" y="6095396"/>
            <a:ext cx="98829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mages of wheat crown rot in the greenhouse with seed not treated (control) or treated with 10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o 10</a:t>
            </a:r>
            <a:r>
              <a:rPr lang="en-US" altLang="zh-CN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FU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/mL of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B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8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640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3"/>
          <a:srcRect t="8420" r="-908"/>
          <a:stretch/>
        </p:blipFill>
        <p:spPr>
          <a:xfrm>
            <a:off x="5718850" y="328875"/>
            <a:ext cx="2594627" cy="2389217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25715" y="2764258"/>
            <a:ext cx="2543024" cy="2454942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2211" t="3310" r="-347" b="1550"/>
          <a:stretch/>
        </p:blipFill>
        <p:spPr>
          <a:xfrm flipH="1">
            <a:off x="5718850" y="2760239"/>
            <a:ext cx="2555664" cy="2458961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25715" y="328875"/>
            <a:ext cx="2543024" cy="2389217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184132" y="5261347"/>
            <a:ext cx="988297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Mycelia morphology of </a:t>
            </a:r>
            <a:r>
              <a:rPr lang="en-US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. </a:t>
            </a:r>
            <a:r>
              <a:rPr lang="en-US" altLang="zh-CN" i="1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seudograminearum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-cultured with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B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85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Mycelia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.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seudograminear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rown on PDA alone at 4 h; (B) Mycelia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.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seudograminear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rown on PDA alone at 16 h; (C) Mycelia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.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seudograminear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-cultured with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B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85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n PDA at 4 h; (D) Mycelia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.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seudograminear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-cultured with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B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185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n PDA at 16 h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227429" y="2394927"/>
            <a:ext cx="4438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</a:p>
          <a:p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5681734" y="2373189"/>
            <a:ext cx="443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3125715" y="4892259"/>
            <a:ext cx="443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5770453" y="4832150"/>
            <a:ext cx="443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cxnSp>
        <p:nvCxnSpPr>
          <p:cNvPr id="18" name="直接连接符 17"/>
          <p:cNvCxnSpPr/>
          <p:nvPr/>
        </p:nvCxnSpPr>
        <p:spPr>
          <a:xfrm>
            <a:off x="5097780" y="2489275"/>
            <a:ext cx="41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7711440" y="2474381"/>
            <a:ext cx="41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7711440" y="4994347"/>
            <a:ext cx="41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5097780" y="4961880"/>
            <a:ext cx="4114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4995269" y="2474381"/>
            <a:ext cx="1032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dobe Devanagari" panose="02040503050201020203" pitchFamily="18" charset="0"/>
                <a:cs typeface="Adobe Devanagari" panose="02040503050201020203" pitchFamily="18" charset="0"/>
              </a:rPr>
              <a:t>10 </a:t>
            </a:r>
            <a:r>
              <a:rPr lang="en-US" altLang="zh-CN" sz="1200" dirty="0" err="1">
                <a:latin typeface="Adobe Devanagari" panose="02040503050201020203" pitchFamily="18" charset="0"/>
                <a:cs typeface="Adobe Devanagari" panose="02040503050201020203" pitchFamily="18" charset="0"/>
              </a:rPr>
              <a:t>μm</a:t>
            </a:r>
            <a:endParaRPr lang="zh-CN" altLang="en-US" sz="1200" dirty="0"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7606479" y="2462166"/>
            <a:ext cx="1032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dobe Devanagari" panose="02040503050201020203" pitchFamily="18" charset="0"/>
                <a:cs typeface="Adobe Devanagari" panose="02040503050201020203" pitchFamily="18" charset="0"/>
              </a:rPr>
              <a:t>10 </a:t>
            </a:r>
            <a:r>
              <a:rPr lang="en-US" altLang="zh-CN" sz="1200" dirty="0" err="1">
                <a:latin typeface="Adobe Devanagari" panose="02040503050201020203" pitchFamily="18" charset="0"/>
                <a:cs typeface="Adobe Devanagari" panose="02040503050201020203" pitchFamily="18" charset="0"/>
              </a:rPr>
              <a:t>μm</a:t>
            </a:r>
            <a:endParaRPr lang="zh-CN" altLang="en-US" sz="1200" dirty="0"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659819" y="4984349"/>
            <a:ext cx="1032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dobe Devanagari" panose="02040503050201020203" pitchFamily="18" charset="0"/>
                <a:cs typeface="Adobe Devanagari" panose="02040503050201020203" pitchFamily="18" charset="0"/>
              </a:rPr>
              <a:t>10 </a:t>
            </a:r>
            <a:r>
              <a:rPr lang="en-US" altLang="zh-CN" sz="1200" dirty="0" err="1">
                <a:latin typeface="Adobe Devanagari" panose="02040503050201020203" pitchFamily="18" charset="0"/>
                <a:cs typeface="Adobe Devanagari" panose="02040503050201020203" pitchFamily="18" charset="0"/>
              </a:rPr>
              <a:t>μm</a:t>
            </a:r>
            <a:endParaRPr lang="zh-CN" altLang="en-US" sz="1200" dirty="0"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044238" y="4975489"/>
            <a:ext cx="1032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dobe Devanagari" panose="02040503050201020203" pitchFamily="18" charset="0"/>
                <a:cs typeface="Adobe Devanagari" panose="02040503050201020203" pitchFamily="18" charset="0"/>
              </a:rPr>
              <a:t>20 </a:t>
            </a:r>
            <a:r>
              <a:rPr lang="en-US" altLang="zh-CN" sz="1200" dirty="0" err="1">
                <a:latin typeface="Adobe Devanagari" panose="02040503050201020203" pitchFamily="18" charset="0"/>
                <a:cs typeface="Adobe Devanagari" panose="02040503050201020203" pitchFamily="18" charset="0"/>
              </a:rPr>
              <a:t>μm</a:t>
            </a:r>
            <a:endParaRPr lang="zh-CN" altLang="en-US" sz="1200" dirty="0"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0699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3293892" y="6399456"/>
            <a:ext cx="69923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</a:rPr>
              <a:t>Figure S3</a:t>
            </a:r>
            <a:r>
              <a:rPr lang="en-US" altLang="zh-CN" dirty="0">
                <a:latin typeface="Times New Roman" panose="02020603050405020304" pitchFamily="18" charset="0"/>
              </a:rPr>
              <a:t>. </a:t>
            </a:r>
            <a:r>
              <a:rPr lang="en-US" altLang="zh-CN" dirty="0" err="1">
                <a:latin typeface="Times New Roman" panose="02020603050405020304" pitchFamily="18" charset="0"/>
              </a:rPr>
              <a:t>Heatmap</a:t>
            </a:r>
            <a:r>
              <a:rPr lang="en-US" altLang="zh-CN" dirty="0">
                <a:latin typeface="Times New Roman" panose="02020603050405020304" pitchFamily="18" charset="0"/>
              </a:rPr>
              <a:t> of Person’s correlation coefficients between samples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3972" b="18680"/>
          <a:stretch/>
        </p:blipFill>
        <p:spPr>
          <a:xfrm>
            <a:off x="2942512" y="160440"/>
            <a:ext cx="7251689" cy="6239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29442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950614" y="5168118"/>
            <a:ext cx="10363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Principal component analysis of the RNA-Seq data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usarium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pseudograminear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o-cultured with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acillus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velezensis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YB-185</a:t>
            </a:r>
            <a:endParaRPr lang="zh-CN" altLang="en-US" kern="1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46" b="20616"/>
          <a:stretch/>
        </p:blipFill>
        <p:spPr>
          <a:xfrm>
            <a:off x="1483063" y="851462"/>
            <a:ext cx="8475748" cy="41641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3658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23153" y="4526816"/>
            <a:ext cx="112072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5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Gene expression distributions of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usarium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pseudograminearum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co-cultured with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acillus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velezensis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YB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-185. (A) The violin plot showing the overall expression levels of samples. The y-axis corresponds to samples’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log</a:t>
            </a:r>
            <a:r>
              <a:rPr lang="en-US" altLang="zh-CN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10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PKM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, (B)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PKM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density distribution of samples. The y-axis corresponds to gene density, and the x-axis displays the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log10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(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PKM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of samples.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25" t="7337" r="11176" b="26910"/>
          <a:stretch/>
        </p:blipFill>
        <p:spPr>
          <a:xfrm>
            <a:off x="6971164" y="1253601"/>
            <a:ext cx="5074690" cy="253556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4" t="7938" r="683" b="13590"/>
          <a:stretch/>
        </p:blipFill>
        <p:spPr>
          <a:xfrm>
            <a:off x="516047" y="1236729"/>
            <a:ext cx="6319263" cy="279206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94106" y="3789161"/>
            <a:ext cx="4438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</a:p>
          <a:p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6953053" y="3705627"/>
            <a:ext cx="4438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 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521079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1960535" y="5595920"/>
            <a:ext cx="112072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6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ene ontology classification of differentially expressed genes. 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080" b="20310"/>
          <a:stretch/>
        </p:blipFill>
        <p:spPr>
          <a:xfrm>
            <a:off x="521001" y="-68580"/>
            <a:ext cx="9194499" cy="5501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5085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2984720" y="6107835"/>
            <a:ext cx="732278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7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KEGG enrichment analysis of differentially expressed genes. 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65" r="559" b="19076"/>
          <a:stretch/>
        </p:blipFill>
        <p:spPr>
          <a:xfrm>
            <a:off x="2426329" y="373709"/>
            <a:ext cx="7161291" cy="5538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87883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1335046" y="5838083"/>
            <a:ext cx="1000886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8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 RT-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PCR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validation of selected genes sampled at 4 h and 16 h. Error bars shows ± SD among the biological triplicates.</a:t>
            </a:r>
            <a:endParaRPr lang="zh-CN" altLang="zh-CN" kern="1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086" y="0"/>
            <a:ext cx="10724052" cy="58380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0917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53</TotalTime>
  <Words>275</Words>
  <Application>Microsoft Office PowerPoint</Application>
  <PresentationFormat>Widescreen</PresentationFormat>
  <Paragraphs>24</Paragraphs>
  <Slides>8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等线</vt:lpstr>
      <vt:lpstr>等线 Light</vt:lpstr>
      <vt:lpstr>Adobe Devanagari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</dc:creator>
  <cp:lastModifiedBy>MDPI-85</cp:lastModifiedBy>
  <cp:revision>75</cp:revision>
  <dcterms:created xsi:type="dcterms:W3CDTF">2021-01-26T10:32:02Z</dcterms:created>
  <dcterms:modified xsi:type="dcterms:W3CDTF">2022-07-22T15:40:22Z</dcterms:modified>
</cp:coreProperties>
</file>